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99300" cy="10234613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C8E2E-BD4A-466C-A955-95B5D5346BE3}" type="datetimeFigureOut">
              <a:rPr lang="es-ES_tradnl" smtClean="0"/>
              <a:pPr/>
              <a:t>23/04/201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59FAA-FC0D-4D4F-BDE8-0A7CBCA4721F}" type="slidenum">
              <a:rPr lang="es-ES_tradnl" smtClean="0"/>
              <a:pPr/>
              <a:t>‹#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1619672" y="188640"/>
            <a:ext cx="5184577" cy="4680521"/>
            <a:chOff x="1259632" y="1196752"/>
            <a:chExt cx="5184577" cy="4680521"/>
          </a:xfrm>
        </p:grpSpPr>
        <p:sp>
          <p:nvSpPr>
            <p:cNvPr id="4" name="Oval 3"/>
            <p:cNvSpPr/>
            <p:nvPr/>
          </p:nvSpPr>
          <p:spPr>
            <a:xfrm>
              <a:off x="2339752" y="2132856"/>
              <a:ext cx="1656184" cy="1656184"/>
            </a:xfrm>
            <a:prstGeom prst="ellipse">
              <a:avLst/>
            </a:prstGeom>
            <a:noFill/>
            <a:ln w="5080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Oval 4"/>
            <p:cNvSpPr/>
            <p:nvPr/>
          </p:nvSpPr>
          <p:spPr>
            <a:xfrm>
              <a:off x="3707904" y="2132856"/>
              <a:ext cx="1656184" cy="1656184"/>
            </a:xfrm>
            <a:prstGeom prst="ellipse">
              <a:avLst/>
            </a:prstGeom>
            <a:noFill/>
            <a:ln w="5080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Oval 5"/>
            <p:cNvSpPr/>
            <p:nvPr/>
          </p:nvSpPr>
          <p:spPr>
            <a:xfrm>
              <a:off x="3707904" y="3501008"/>
              <a:ext cx="1656184" cy="1656184"/>
            </a:xfrm>
            <a:prstGeom prst="ellipse">
              <a:avLst/>
            </a:prstGeom>
            <a:noFill/>
            <a:ln w="5080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Oval 6"/>
            <p:cNvSpPr/>
            <p:nvPr/>
          </p:nvSpPr>
          <p:spPr>
            <a:xfrm>
              <a:off x="2339752" y="3501008"/>
              <a:ext cx="1656184" cy="1656184"/>
            </a:xfrm>
            <a:prstGeom prst="ellipse">
              <a:avLst/>
            </a:prstGeom>
            <a:noFill/>
            <a:ln w="50800" cmpd="dbl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543609" y="2568795"/>
              <a:ext cx="102027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HIP Phase I</a:t>
              </a:r>
            </a:p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59 genes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05517" y="2564904"/>
              <a:ext cx="106356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HIP Phase II</a:t>
              </a:r>
            </a:p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07 genes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14334" y="4149080"/>
              <a:ext cx="114050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HOP Phase II</a:t>
              </a:r>
            </a:p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39 genes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22945" y="4149080"/>
              <a:ext cx="109722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HOP Phase I</a:t>
              </a:r>
            </a:p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84 genes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707904" y="2780928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07904" y="4221088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059832" y="3501008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27984" y="3501008"/>
              <a:ext cx="2696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16167" y="1196752"/>
              <a:ext cx="2159889" cy="738664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</a:ln>
          </p:spPr>
          <p:txBody>
            <a:bodyPr wrap="square" numCol="2" rtlCol="0">
              <a:spAutoFit/>
            </a:bodyPr>
            <a:lstStyle/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PGS1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RNQ1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PL102C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FMP30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DAP1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RBD2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HR086W-A</a:t>
              </a: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V="1">
              <a:off x="3851920" y="1916832"/>
              <a:ext cx="0" cy="6480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rot="16200000" flipV="1">
              <a:off x="2375756" y="3320988"/>
              <a:ext cx="0" cy="6480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>
              <a:off x="3851920" y="4797152"/>
              <a:ext cx="0" cy="6480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rot="5400000" flipV="1">
              <a:off x="5328084" y="3320988"/>
              <a:ext cx="0" cy="64807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5652121" y="3429000"/>
              <a:ext cx="792088" cy="415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</a:ln>
          </p:spPr>
          <p:txBody>
            <a:bodyPr wrap="square" numCol="1" rtlCol="0">
              <a:spAutoFit/>
            </a:bodyPr>
            <a:lstStyle/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CR025C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PL102C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15816" y="5445225"/>
              <a:ext cx="2160240" cy="432048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</a:ln>
          </p:spPr>
          <p:txBody>
            <a:bodyPr wrap="square" numCol="2" rtlCol="0">
              <a:spAutoFit/>
            </a:bodyPr>
            <a:lstStyle/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EMC5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UFD4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GSF2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OR055W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259632" y="3356992"/>
              <a:ext cx="792088" cy="577081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</a:ln>
          </p:spPr>
          <p:txBody>
            <a:bodyPr wrap="square" numCol="1" rtlCol="0">
              <a:spAutoFit/>
            </a:bodyPr>
            <a:lstStyle/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INO4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YPL261C</a:t>
              </a:r>
            </a:p>
            <a:p>
              <a:r>
                <a:rPr lang="en-US" sz="1050" b="1" dirty="0" smtClean="0">
                  <a:latin typeface="Arial" pitchFamily="34" charset="0"/>
                  <a:cs typeface="Arial" pitchFamily="34" charset="0"/>
                </a:rPr>
                <a:t>RLF2</a:t>
              </a:r>
            </a:p>
          </p:txBody>
        </p:sp>
      </p:grpSp>
      <p:sp>
        <p:nvSpPr>
          <p:cNvPr id="49" name="Rectangle 48"/>
          <p:cNvSpPr/>
          <p:nvPr/>
        </p:nvSpPr>
        <p:spPr>
          <a:xfrm>
            <a:off x="1043608" y="5805264"/>
            <a:ext cx="76328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>
              <a:lnSpc>
                <a:spcPct val="150000"/>
              </a:lnSpc>
              <a:spcAft>
                <a:spcPts val="0"/>
              </a:spcAft>
            </a:pPr>
            <a:r>
              <a:rPr lang="en-US" sz="1200" b="1" dirty="0" smtClean="0">
                <a:latin typeface="Arial"/>
              </a:rPr>
              <a:t>Figure S1: </a:t>
            </a:r>
            <a:r>
              <a:rPr lang="en-US" sz="1200" dirty="0" smtClean="0">
                <a:latin typeface="Arial"/>
              </a:rPr>
              <a:t>Shared genes among those highlighted in </a:t>
            </a:r>
            <a:r>
              <a:rPr lang="en-US" sz="1200" smtClean="0">
                <a:latin typeface="Arial"/>
              </a:rPr>
              <a:t>different analyses </a:t>
            </a:r>
            <a:r>
              <a:rPr lang="en-US" sz="1200" dirty="0" smtClean="0">
                <a:latin typeface="Arial"/>
              </a:rPr>
              <a:t>and fermentation Phases.</a:t>
            </a:r>
            <a:endParaRPr lang="en-US" sz="2400" b="1" dirty="0">
              <a:latin typeface="Times New Roman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55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ilar y Ramón</dc:creator>
  <cp:lastModifiedBy>Ramón González García</cp:lastModifiedBy>
  <cp:revision>11</cp:revision>
  <dcterms:created xsi:type="dcterms:W3CDTF">2012-06-12T18:15:54Z</dcterms:created>
  <dcterms:modified xsi:type="dcterms:W3CDTF">2013-04-23T08:20:09Z</dcterms:modified>
</cp:coreProperties>
</file>